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20040-8C90-46E6-A76D-199B6AB4E9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9776E-6D70-4D77-AF50-30B5022606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E844B-D86A-4CD3-A5AE-A2B78391C8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516BC-94FE-49B2-AC5A-73A739BA56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1870C-FDA7-467E-A4BF-78E4EBE8AD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F13BE-0C92-4B13-BFB1-24759DEFBC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B25BD-B1F9-459F-A3F6-04A74A0D37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2D6CE-598E-4096-B8D6-42B31AC55C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6AA96-7DCD-4195-B09D-6517CC9593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FD20E-37F9-4972-8353-B5C3864F3A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70919-D632-4BDC-AA9C-74E12C3B52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BA485-1A99-4509-88D4-6483554338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382F67-FECC-47FE-903C-8C21B153DDD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6858000" cy="9215280"/>
        </p:xfrm>
        <a:graphic>
          <a:graphicData uri="http://schemas.openxmlformats.org/drawingml/2006/table">
            <a:tbl>
              <a:tblPr/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ubject Spec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oma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CBI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xonomy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NCBI RefSeq Protei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CBI Genom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ject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7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lamydia trachomatis A/HAR-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5277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8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scherichia coli O157:H7 str. Saka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6585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ctococcus lactis subsp. lactis Il14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262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ceanobacillus iheyensis HTE8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110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dopirellula baltica SH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309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lmonella typhimurium LT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287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ewanella oneidensis MR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1586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rsinia pestis KI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41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steria monocytogenes str. 4b F23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c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566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enorhabditis elega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2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osophila melanogas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7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o sapie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6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cephalitozoon cuniculi GB-M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481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8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odium falciparum 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ukary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3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8T20:33:31Z</dcterms:created>
  <dc:creator>sichan</dc:creator>
  <dc:description/>
  <dc:language>en-US</dc:language>
  <cp:lastModifiedBy>sichan</cp:lastModifiedBy>
  <dcterms:modified xsi:type="dcterms:W3CDTF">2007-06-13T18:02:59Z</dcterms:modified>
  <cp:revision>10</cp:revision>
  <dc:subject/>
  <dc:title>Slide 1</dc:title>
</cp:coreProperties>
</file>